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9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10ADF67-1DE4-4D38-A085-BEF2F6932AD5}" v="1" dt="2025-11-21T17:37:40.526"/>
    <p1510:client id="{C393D3FC-F337-4887-B3C1-271A0C439DF7}" v="1" dt="2025-11-21T17:33:42.11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55" autoAdjust="0"/>
    <p:restoredTop sz="94660"/>
  </p:normalViewPr>
  <p:slideViewPr>
    <p:cSldViewPr snapToGrid="0">
      <p:cViewPr varScale="1">
        <p:scale>
          <a:sx n="43" d="100"/>
          <a:sy n="43" d="100"/>
        </p:scale>
        <p:origin x="54" y="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DC337-203F-6ACA-81AC-A8CD27A5AE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9D7B5D-55B0-0F5B-6BA0-DC90372DD4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04F32-11AA-CBE5-2813-45379BA1F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299BDA-A4D5-5426-1C32-74827FEEF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B5029E-681C-D8EA-A9CB-183241D8F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90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EB47E-F2C1-413F-B074-279E0D348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D872DB-08DE-46C0-9BE7-C9EA6F70CF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F2B9D5-E42C-8729-D31B-A4C4FFFC2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023C39-0265-A664-15E0-F0096A2F5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B05800-E7E3-DEA3-F080-8507E4D9C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546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4666AB-3A2A-CAEC-CCB0-2D71536B3C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E2294C-2D59-A5D6-2BB4-5F224E22D2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8C372F-A7A7-E7B0-F777-9CFD14855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BE6756-259C-5BDB-275F-725DCB4E8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152E30-8BB8-6455-1F33-5535A5DF3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901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A5150-CAE5-4302-4470-A41AD735A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25F923-B478-8748-7F7D-2781A5F69C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D437E4-8C26-5284-E89D-FACD8C431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B7BBD2-44EF-10AD-EA54-166AB146C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019E2B-FA57-B58C-DA85-FACDE38D7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35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4D0AF-E17E-151C-EE82-E6F69A538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EE6578-DA8B-EE9A-84AE-827EC7379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F4B51F-933B-BF26-83C2-3C0F127D0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B3783-29CD-7E76-8B07-F52AFCF91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079BBE-A69E-4052-D46A-EFE735E63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462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78B95-B489-6691-A121-9CC6C4B712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C91E10-CD3D-3EDC-DFB0-803D967D56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333D40-635E-6ABB-1B03-872F3BE745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E6EE93-F983-49B8-E287-350ACD5A5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60D05B-83E8-E736-62CA-978BDAC89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93DB88-7FCA-805B-B25D-A15ED303A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058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2B4D2-B742-74AD-7E4F-1C36C8BF38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63AD43-55EA-D2A5-C714-0F0235245F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4C5E5-8085-43E6-0982-479004178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4259B2-C329-5225-AFC6-1C45D9A8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7D774B-43D2-0E6E-192B-05B59342A2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031BED-9BF2-1594-9AF9-A8C3F8574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4B5B88-637B-2382-48A0-432B9BCA7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96C8DB-709D-927A-830E-6AA222BC3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174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449D5E-0BC9-365E-FBD0-5C50E02B1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96A71A-9EAC-E539-A92E-A8C4A2D89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358E02-2118-7788-D756-007982747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31ED9F-AC4C-29FD-4CB8-C8FF1F5E6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472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886813-0D54-97B1-9E59-858D295EA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2F8018-E02D-A9CE-D719-36E85435A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90113A-1DA2-D8A0-5CA8-0ED75C829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972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43400C-96A9-3332-9F54-0E6371A59D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3E3DF7-C799-1095-64F8-E94B03841B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E82F2-DA81-4ABB-2630-6746143C0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19D5D2-2449-89D1-2373-E4AF24D1C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9B6FAA-D7A8-C85A-18DA-83379ECCA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519064-18BA-1CDB-19AA-2A29554E3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188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87BDD-9463-3AED-548E-435A5322B0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4E64A2-3F6D-03EB-E76D-5046D5A6C0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43AA9C-110C-6439-5410-F3CF4C84BC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390388-7848-4138-531B-EF7F15E21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5C8E1D-B33D-C775-C3DB-16B67AF93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BB3E97-98B0-29A3-9A63-2EA4A8910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734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B1D7BD-CDAC-68DD-C607-2E71AB3D3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BC608A-12FF-754B-AF73-6DDBDF80C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5060F9-A318-F7D9-7F7A-431771AB91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A5AA70-A864-7D31-742F-E7BD4D0D15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1EC38-407C-52B9-1DA8-1E0EBDCB00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81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22B816F-2CBA-2498-D09B-AC71BF74D70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>
            <a:extLst>
              <a:ext uri="{FF2B5EF4-FFF2-40B4-BE49-F238E27FC236}">
                <a16:creationId xmlns:a16="http://schemas.microsoft.com/office/drawing/2014/main" id="{0971A912-BBF8-95B5-3EAB-B5FF6134455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207" t="17169" r="26560" b="17260"/>
          <a:stretch/>
        </p:blipFill>
        <p:spPr>
          <a:xfrm>
            <a:off x="6266409" y="1699223"/>
            <a:ext cx="4674075" cy="3737472"/>
          </a:xfrm>
          <a:prstGeom prst="rect">
            <a:avLst/>
          </a:prstGeom>
          <a:ln>
            <a:noFill/>
          </a:ln>
        </p:spPr>
      </p:pic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904EF107-823F-68DE-2E1D-ADBEC59D280D}"/>
              </a:ext>
            </a:extLst>
          </p:cNvPr>
          <p:cNvCxnSpPr/>
          <p:nvPr/>
        </p:nvCxnSpPr>
        <p:spPr>
          <a:xfrm flipH="1">
            <a:off x="7431259" y="1528759"/>
            <a:ext cx="8238" cy="2388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D9AB8ED5-5DDD-DC39-E529-CCAFE7F74772}"/>
              </a:ext>
            </a:extLst>
          </p:cNvPr>
          <p:cNvSpPr txBox="1"/>
          <p:nvPr/>
        </p:nvSpPr>
        <p:spPr>
          <a:xfrm>
            <a:off x="8202431" y="5278038"/>
            <a:ext cx="17908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lcia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Blue Stain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ect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istochemistry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382D03B-F844-4265-1FEE-BA8251CE30C5}"/>
              </a:ext>
            </a:extLst>
          </p:cNvPr>
          <p:cNvSpPr/>
          <p:nvPr/>
        </p:nvSpPr>
        <p:spPr>
          <a:xfrm>
            <a:off x="8740060" y="4595263"/>
            <a:ext cx="566531" cy="596348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95EEB0C-4B0F-F832-0872-DDA53028A3FF}"/>
              </a:ext>
            </a:extLst>
          </p:cNvPr>
          <p:cNvSpPr/>
          <p:nvPr/>
        </p:nvSpPr>
        <p:spPr>
          <a:xfrm>
            <a:off x="6323459" y="945142"/>
            <a:ext cx="1124584" cy="12720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07D09EE-3E79-0C6B-972D-216B0B087988}"/>
              </a:ext>
            </a:extLst>
          </p:cNvPr>
          <p:cNvSpPr txBox="1"/>
          <p:nvPr/>
        </p:nvSpPr>
        <p:spPr>
          <a:xfrm>
            <a:off x="7684368" y="1796809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omach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iscarded</a:t>
            </a:r>
          </a:p>
        </p:txBody>
      </p:sp>
      <p:sp>
        <p:nvSpPr>
          <p:cNvPr id="21" name="Right Bracket 20">
            <a:extLst>
              <a:ext uri="{FF2B5EF4-FFF2-40B4-BE49-F238E27FC236}">
                <a16:creationId xmlns:a16="http://schemas.microsoft.com/office/drawing/2014/main" id="{B2688443-5EEA-609B-8E25-78F4558FD455}"/>
              </a:ext>
            </a:extLst>
          </p:cNvPr>
          <p:cNvSpPr/>
          <p:nvPr/>
        </p:nvSpPr>
        <p:spPr>
          <a:xfrm rot="16200000">
            <a:off x="8585460" y="1468842"/>
            <a:ext cx="110125" cy="876183"/>
          </a:xfrm>
          <a:prstGeom prst="righ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ight Bracket 41">
            <a:extLst>
              <a:ext uri="{FF2B5EF4-FFF2-40B4-BE49-F238E27FC236}">
                <a16:creationId xmlns:a16="http://schemas.microsoft.com/office/drawing/2014/main" id="{52AE92B9-7D19-C81D-C3A2-432E9D72728F}"/>
              </a:ext>
            </a:extLst>
          </p:cNvPr>
          <p:cNvSpPr/>
          <p:nvPr/>
        </p:nvSpPr>
        <p:spPr>
          <a:xfrm rot="16200000">
            <a:off x="9500152" y="1455884"/>
            <a:ext cx="110125" cy="876183"/>
          </a:xfrm>
          <a:prstGeom prst="righ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81906DD-55FA-D528-8C1F-A19D0E0DE948}"/>
              </a:ext>
            </a:extLst>
          </p:cNvPr>
          <p:cNvSpPr txBox="1"/>
          <p:nvPr/>
        </p:nvSpPr>
        <p:spPr>
          <a:xfrm>
            <a:off x="8258786" y="1356182"/>
            <a:ext cx="7634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mall Intestine 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5754A31-94D8-D443-6031-876C738DFD8E}"/>
              </a:ext>
            </a:extLst>
          </p:cNvPr>
          <p:cNvSpPr txBox="1"/>
          <p:nvPr/>
        </p:nvSpPr>
        <p:spPr>
          <a:xfrm>
            <a:off x="9173478" y="1517486"/>
            <a:ext cx="7634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on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868B81E-0041-150A-03B3-5399EB6DB738}"/>
              </a:ext>
            </a:extLst>
          </p:cNvPr>
          <p:cNvSpPr txBox="1"/>
          <p:nvPr/>
        </p:nvSpPr>
        <p:spPr>
          <a:xfrm>
            <a:off x="9936949" y="2272822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ectum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iscarde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3845E21-0D2D-00D4-4207-2A1C2E1B25CD}"/>
              </a:ext>
            </a:extLst>
          </p:cNvPr>
          <p:cNvSpPr txBox="1"/>
          <p:nvPr/>
        </p:nvSpPr>
        <p:spPr>
          <a:xfrm>
            <a:off x="1377609" y="492640"/>
            <a:ext cx="5835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5E8EDB0-F1E1-0CA4-3698-CD2A82C903BD}"/>
              </a:ext>
            </a:extLst>
          </p:cNvPr>
          <p:cNvSpPr txBox="1"/>
          <p:nvPr/>
        </p:nvSpPr>
        <p:spPr>
          <a:xfrm>
            <a:off x="1323972" y="2727393"/>
            <a:ext cx="5835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8A0EFE9-AE7B-4E50-C047-C762BA932645}"/>
              </a:ext>
            </a:extLst>
          </p:cNvPr>
          <p:cNvSpPr txBox="1"/>
          <p:nvPr/>
        </p:nvSpPr>
        <p:spPr>
          <a:xfrm>
            <a:off x="4872945" y="2804337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hort 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412F373-A116-84A7-9E52-642009A7C35B}"/>
              </a:ext>
            </a:extLst>
          </p:cNvPr>
          <p:cNvSpPr txBox="1"/>
          <p:nvPr/>
        </p:nvSpPr>
        <p:spPr>
          <a:xfrm>
            <a:off x="2968043" y="2774599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hort 1</a:t>
            </a: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62ABBE9F-2B62-8C6F-E324-28C8C6704835}"/>
              </a:ext>
            </a:extLst>
          </p:cNvPr>
          <p:cNvGraphicFramePr>
            <a:graphicFrameLocks noGrp="1"/>
          </p:cNvGraphicFramePr>
          <p:nvPr/>
        </p:nvGraphicFramePr>
        <p:xfrm>
          <a:off x="1323972" y="3254976"/>
          <a:ext cx="4737101" cy="916305"/>
        </p:xfrm>
        <a:graphic>
          <a:graphicData uri="http://schemas.openxmlformats.org/drawingml/2006/table">
            <a:tbl>
              <a:tblPr/>
              <a:tblGrid>
                <a:gridCol w="11668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65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6927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185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8049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4390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6487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1853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93173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40585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409027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UDY GROUP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 trea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 trea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ïv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AI PB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A CF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9024A139-E391-23F4-76D4-1D943F0CE82E}"/>
              </a:ext>
            </a:extLst>
          </p:cNvPr>
          <p:cNvSpPr txBox="1"/>
          <p:nvPr/>
        </p:nvSpPr>
        <p:spPr>
          <a:xfrm>
            <a:off x="2919553" y="2993366"/>
            <a:ext cx="8114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AC time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B24721E-DF89-A162-9ABB-5588CA13B0F6}"/>
              </a:ext>
            </a:extLst>
          </p:cNvPr>
          <p:cNvSpPr txBox="1"/>
          <p:nvPr/>
        </p:nvSpPr>
        <p:spPr>
          <a:xfrm>
            <a:off x="4829664" y="3029551"/>
            <a:ext cx="8114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AC time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F407F4D-4621-4A44-DB15-AC141416F590}"/>
              </a:ext>
            </a:extLst>
          </p:cNvPr>
          <p:cNvGrpSpPr/>
          <p:nvPr/>
        </p:nvGrpSpPr>
        <p:grpSpPr>
          <a:xfrm>
            <a:off x="1615741" y="550269"/>
            <a:ext cx="3514788" cy="2094047"/>
            <a:chOff x="910938" y="914731"/>
            <a:chExt cx="3514788" cy="2094047"/>
          </a:xfrm>
        </p:grpSpPr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2B6B8B33-804A-A2C2-BF45-8849BF5808D3}"/>
                </a:ext>
              </a:extLst>
            </p:cNvPr>
            <p:cNvCxnSpPr>
              <a:cxnSpLocks/>
            </p:cNvCxnSpPr>
            <p:nvPr/>
          </p:nvCxnSpPr>
          <p:spPr>
            <a:xfrm>
              <a:off x="1090369" y="1882347"/>
              <a:ext cx="547033" cy="4295"/>
            </a:xfrm>
            <a:prstGeom prst="line">
              <a:avLst/>
            </a:prstGeom>
            <a:ln w="38100"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7C5E029-B7B7-F01D-A080-A0395D635D24}"/>
                </a:ext>
              </a:extLst>
            </p:cNvPr>
            <p:cNvSpPr txBox="1"/>
            <p:nvPr/>
          </p:nvSpPr>
          <p:spPr>
            <a:xfrm>
              <a:off x="2324086" y="1701704"/>
              <a:ext cx="42511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 dirty="0">
                  <a:latin typeface="Arial" panose="020B0604020202020204" pitchFamily="34" charset="0"/>
                  <a:cs typeface="Arial" panose="020B0604020202020204" pitchFamily="34" charset="0"/>
                </a:rPr>
                <a:t>3d 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90D0609-7D07-2DE4-A74E-C7E043842437}"/>
                </a:ext>
              </a:extLst>
            </p:cNvPr>
            <p:cNvSpPr txBox="1"/>
            <p:nvPr/>
          </p:nvSpPr>
          <p:spPr>
            <a:xfrm>
              <a:off x="3005705" y="1720300"/>
              <a:ext cx="42511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 dirty="0">
                  <a:latin typeface="Arial" panose="020B0604020202020204" pitchFamily="34" charset="0"/>
                  <a:cs typeface="Arial" panose="020B0604020202020204" pitchFamily="34" charset="0"/>
                </a:rPr>
                <a:t>7d 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E689B84-0733-6819-195E-EA241E446D9C}"/>
                </a:ext>
              </a:extLst>
            </p:cNvPr>
            <p:cNvSpPr txBox="1"/>
            <p:nvPr/>
          </p:nvSpPr>
          <p:spPr>
            <a:xfrm>
              <a:off x="3695005" y="1727321"/>
              <a:ext cx="521297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 dirty="0">
                  <a:latin typeface="Arial" panose="020B0604020202020204" pitchFamily="34" charset="0"/>
                  <a:cs typeface="Arial" panose="020B0604020202020204" pitchFamily="34" charset="0"/>
                </a:rPr>
                <a:t>14d 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C1202F7-0E64-9A88-1BC7-98741D1D36CF}"/>
                </a:ext>
              </a:extLst>
            </p:cNvPr>
            <p:cNvSpPr txBox="1"/>
            <p:nvPr/>
          </p:nvSpPr>
          <p:spPr>
            <a:xfrm>
              <a:off x="1569317" y="1712519"/>
              <a:ext cx="523876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50" dirty="0">
                  <a:latin typeface="Arial" panose="020B0604020202020204" pitchFamily="34" charset="0"/>
                  <a:cs typeface="Arial" panose="020B0604020202020204" pitchFamily="34" charset="0"/>
                </a:rPr>
                <a:t>Pre </a:t>
              </a:r>
            </a:p>
          </p:txBody>
        </p:sp>
        <p:sp>
          <p:nvSpPr>
            <p:cNvPr id="14" name="Down Arrow 5">
              <a:extLst>
                <a:ext uri="{FF2B5EF4-FFF2-40B4-BE49-F238E27FC236}">
                  <a16:creationId xmlns:a16="http://schemas.microsoft.com/office/drawing/2014/main" id="{1D3A5824-D09A-513A-A89F-749BC5E89A69}"/>
                </a:ext>
              </a:extLst>
            </p:cNvPr>
            <p:cNvSpPr/>
            <p:nvPr/>
          </p:nvSpPr>
          <p:spPr>
            <a:xfrm>
              <a:off x="2435201" y="1946407"/>
              <a:ext cx="126751" cy="240481"/>
            </a:xfrm>
            <a:prstGeom prst="downArrow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Down Arrow 6">
              <a:extLst>
                <a:ext uri="{FF2B5EF4-FFF2-40B4-BE49-F238E27FC236}">
                  <a16:creationId xmlns:a16="http://schemas.microsoft.com/office/drawing/2014/main" id="{347D106D-C7D2-3D20-3351-C911DD01AE3E}"/>
                </a:ext>
              </a:extLst>
            </p:cNvPr>
            <p:cNvSpPr/>
            <p:nvPr/>
          </p:nvSpPr>
          <p:spPr>
            <a:xfrm>
              <a:off x="3115664" y="1949194"/>
              <a:ext cx="135985" cy="237550"/>
            </a:xfrm>
            <a:prstGeom prst="downArrow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Down Arrow 7">
              <a:extLst>
                <a:ext uri="{FF2B5EF4-FFF2-40B4-BE49-F238E27FC236}">
                  <a16:creationId xmlns:a16="http://schemas.microsoft.com/office/drawing/2014/main" id="{E58B8DC1-83EC-6952-725A-0D394FA21CF8}"/>
                </a:ext>
              </a:extLst>
            </p:cNvPr>
            <p:cNvSpPr/>
            <p:nvPr/>
          </p:nvSpPr>
          <p:spPr>
            <a:xfrm>
              <a:off x="3830614" y="1968208"/>
              <a:ext cx="126751" cy="229798"/>
            </a:xfrm>
            <a:prstGeom prst="downArrow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C22466C-B62F-970D-8145-2FB7BFEE52BC}"/>
                </a:ext>
              </a:extLst>
            </p:cNvPr>
            <p:cNvSpPr txBox="1"/>
            <p:nvPr/>
          </p:nvSpPr>
          <p:spPr>
            <a:xfrm>
              <a:off x="1014729" y="1856952"/>
              <a:ext cx="7243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cclimation</a:t>
              </a:r>
            </a:p>
            <a:p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14 days</a:t>
              </a:r>
            </a:p>
          </p:txBody>
        </p:sp>
        <p:sp>
          <p:nvSpPr>
            <p:cNvPr id="22" name="Down Arrow 5">
              <a:extLst>
                <a:ext uri="{FF2B5EF4-FFF2-40B4-BE49-F238E27FC236}">
                  <a16:creationId xmlns:a16="http://schemas.microsoft.com/office/drawing/2014/main" id="{EE502474-6B46-47B3-65E4-2E32093E9D6D}"/>
                </a:ext>
              </a:extLst>
            </p:cNvPr>
            <p:cNvSpPr/>
            <p:nvPr/>
          </p:nvSpPr>
          <p:spPr>
            <a:xfrm>
              <a:off x="1747627" y="1941787"/>
              <a:ext cx="126751" cy="240481"/>
            </a:xfrm>
            <a:prstGeom prst="downArrow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CF252DB6-002B-9AD2-8436-36320CE0CD29}"/>
                </a:ext>
              </a:extLst>
            </p:cNvPr>
            <p:cNvCxnSpPr>
              <a:cxnSpLocks/>
            </p:cNvCxnSpPr>
            <p:nvPr/>
          </p:nvCxnSpPr>
          <p:spPr>
            <a:xfrm>
              <a:off x="1943197" y="1867979"/>
              <a:ext cx="456429" cy="346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999A0C0E-18F6-7C3B-A92A-EB76332E2D50}"/>
                </a:ext>
              </a:extLst>
            </p:cNvPr>
            <p:cNvCxnSpPr>
              <a:cxnSpLocks/>
            </p:cNvCxnSpPr>
            <p:nvPr/>
          </p:nvCxnSpPr>
          <p:spPr>
            <a:xfrm>
              <a:off x="2613109" y="1877362"/>
              <a:ext cx="456429" cy="346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0A362A95-5B00-55E1-474F-B7C0AE79B27C}"/>
                </a:ext>
              </a:extLst>
            </p:cNvPr>
            <p:cNvCxnSpPr>
              <a:cxnSpLocks/>
            </p:cNvCxnSpPr>
            <p:nvPr/>
          </p:nvCxnSpPr>
          <p:spPr>
            <a:xfrm>
              <a:off x="3321717" y="1874174"/>
              <a:ext cx="456429" cy="346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7497473-CB98-2C2B-00B8-991F2C5CD4AB}"/>
                </a:ext>
              </a:extLst>
            </p:cNvPr>
            <p:cNvSpPr txBox="1"/>
            <p:nvPr/>
          </p:nvSpPr>
          <p:spPr>
            <a:xfrm>
              <a:off x="1168003" y="2454780"/>
              <a:ext cx="3257723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Joint diameter measurement, synovial fluid lavage, ileal and colon feces, hind legs, ileum and colon tissues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987FCA2-AC23-9085-B4A9-947954E83AA5}"/>
                </a:ext>
              </a:extLst>
            </p:cNvPr>
            <p:cNvSpPr txBox="1"/>
            <p:nvPr/>
          </p:nvSpPr>
          <p:spPr>
            <a:xfrm>
              <a:off x="2245837" y="2197319"/>
              <a:ext cx="528737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AC</a:t>
              </a:r>
            </a:p>
          </p:txBody>
        </p:sp>
        <p:pic>
          <p:nvPicPr>
            <p:cNvPr id="3" name="Picture 2" descr="A diagram of a specific method&#10;&#10;Description automatically generated with medium confidence">
              <a:extLst>
                <a:ext uri="{FF2B5EF4-FFF2-40B4-BE49-F238E27FC236}">
                  <a16:creationId xmlns:a16="http://schemas.microsoft.com/office/drawing/2014/main" id="{4097DBE0-4D24-0481-1758-2CDDB9871A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50" t="15573" r="70481" b="71319"/>
            <a:stretch/>
          </p:blipFill>
          <p:spPr>
            <a:xfrm>
              <a:off x="1295943" y="914731"/>
              <a:ext cx="820132" cy="83898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C045F15-ADD5-0565-9BF7-6056AB552440}"/>
                </a:ext>
              </a:extLst>
            </p:cNvPr>
            <p:cNvSpPr txBox="1"/>
            <p:nvPr/>
          </p:nvSpPr>
          <p:spPr>
            <a:xfrm>
              <a:off x="910938" y="1347182"/>
              <a:ext cx="8322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Sham or CFA</a:t>
              </a:r>
            </a:p>
          </p:txBody>
        </p: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10C4E402-E7FE-9571-1FEC-BE687AFEF301}"/>
              </a:ext>
            </a:extLst>
          </p:cNvPr>
          <p:cNvSpPr txBox="1"/>
          <p:nvPr/>
        </p:nvSpPr>
        <p:spPr>
          <a:xfrm>
            <a:off x="1323972" y="4429585"/>
            <a:ext cx="5835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5D858EB-6B5A-7C5D-A6EF-3FFBE6B1271C}"/>
              </a:ext>
            </a:extLst>
          </p:cNvPr>
          <p:cNvSpPr txBox="1"/>
          <p:nvPr/>
        </p:nvSpPr>
        <p:spPr>
          <a:xfrm>
            <a:off x="83064" y="13174"/>
            <a:ext cx="8338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BDFFD33-13F9-26FC-3B3B-FA540F2C49BF}"/>
              </a:ext>
            </a:extLst>
          </p:cNvPr>
          <p:cNvSpPr txBox="1"/>
          <p:nvPr/>
        </p:nvSpPr>
        <p:spPr>
          <a:xfrm>
            <a:off x="3638803" y="1821100"/>
            <a:ext cx="52873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0D019BA-D303-2BF0-F382-99FFCA4E3EBD}"/>
              </a:ext>
            </a:extLst>
          </p:cNvPr>
          <p:cNvSpPr txBox="1"/>
          <p:nvPr/>
        </p:nvSpPr>
        <p:spPr>
          <a:xfrm>
            <a:off x="4347047" y="1838775"/>
            <a:ext cx="52873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C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583763B-F029-DF11-F6BA-8CF509968DF3}"/>
              </a:ext>
            </a:extLst>
          </p:cNvPr>
          <p:cNvSpPr txBox="1"/>
          <p:nvPr/>
        </p:nvSpPr>
        <p:spPr>
          <a:xfrm>
            <a:off x="6266409" y="1298770"/>
            <a:ext cx="5835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60BD1AF3-39AD-46A6-A037-66BF3B21808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51484" y="4534678"/>
            <a:ext cx="5191125" cy="2124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010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10</Words>
  <Application>Microsoft Office PowerPoint</Application>
  <PresentationFormat>Widescreen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Rush University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ghan Moran</dc:creator>
  <cp:lastModifiedBy>Meghan Moran</cp:lastModifiedBy>
  <cp:revision>28</cp:revision>
  <dcterms:created xsi:type="dcterms:W3CDTF">2025-11-21T17:16:35Z</dcterms:created>
  <dcterms:modified xsi:type="dcterms:W3CDTF">2025-11-21T17:38:02Z</dcterms:modified>
</cp:coreProperties>
</file>